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1" autoAdjust="0"/>
    <p:restoredTop sz="94660"/>
  </p:normalViewPr>
  <p:slideViewPr>
    <p:cSldViewPr showGuides="1">
      <p:cViewPr varScale="1">
        <p:scale>
          <a:sx n="65" d="100"/>
          <a:sy n="65" d="100"/>
        </p:scale>
        <p:origin x="2405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110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6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342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186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20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5113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380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795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9877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6961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9665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5568F-84D3-4814-BA4A-5BDF82981160}" type="datetimeFigureOut">
              <a:rPr lang="zh-CN" altLang="en-US" smtClean="0"/>
              <a:t>2021/8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14717-8203-4837-9C96-CE94F326CF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1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6F244793-911F-4927-95CF-14B61B9FAF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-4698998" y="58517"/>
            <a:ext cx="246286" cy="492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21920" tIns="60961" rIns="121920" bIns="60961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 sz="2401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4583995-0445-450E-9894-C8821F9AAAE4}"/>
              </a:ext>
            </a:extLst>
          </p:cNvPr>
          <p:cNvSpPr txBox="1"/>
          <p:nvPr/>
        </p:nvSpPr>
        <p:spPr>
          <a:xfrm>
            <a:off x="332656" y="5537329"/>
            <a:ext cx="6264696" cy="32111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2340"/>
              </a:spcBef>
              <a:spcAft>
                <a:spcPts val="780"/>
              </a:spcAft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</a:t>
            </a:r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GB" altLang="zh-CN" sz="14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 exhibits normal aboveground growth and development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resentative phenotype of aboveground parts of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T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ants at different stages (counting from the day of germination). Seedlings: 33-d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y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old stage (Scale: 2 cm); flower, dehisced anther, and the main inflorescence: 7-week-old stage; seeds: 13-week-old stage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Fresh weight of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T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nts 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t</a:t>
            </a:r>
            <a:r>
              <a:rPr lang="en-GB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dicated days (counting from the day of germination). Data are means ± SD (n = 11~13 plants)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number of siliques of 8-week-old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T and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nts (counting from the day of germination). Data are means ± SD (n = 10 plants). 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seed weights of 14-week-old WT and </a:t>
            </a:r>
            <a:r>
              <a:rPr lang="en-GB" altLang="zh-CN" sz="14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ib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nts (counting from the day of germination). Data are means ± SD (n = 13~15 plants). 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atistical significance was </a:t>
            </a:r>
            <a:r>
              <a:rPr lang="en-GB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alyzed</a:t>
            </a:r>
            <a:r>
              <a:rPr lang="en-GB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y using Student’s t-test (“ns” means no significant difference, p &gt; 0.05)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13C5106-91AA-441D-BDA0-496B54D1D5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932" y="118100"/>
            <a:ext cx="5660136" cy="51739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344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182</Words>
  <Application>Microsoft Office PowerPoint</Application>
  <PresentationFormat>信纸(8.5x11 英寸)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gnita</dc:creator>
  <cp:lastModifiedBy>Yuwen Li</cp:lastModifiedBy>
  <cp:revision>13</cp:revision>
  <dcterms:created xsi:type="dcterms:W3CDTF">2020-11-11T06:41:23Z</dcterms:created>
  <dcterms:modified xsi:type="dcterms:W3CDTF">2021-08-06T04:42:46Z</dcterms:modified>
</cp:coreProperties>
</file>